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F1EAE9F-5AB6-4436-B997-BB77AC0D81F3}" v="1" dt="2025-10-30T16:11:37.1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66" d="100"/>
          <a:sy n="66" d="100"/>
        </p:scale>
        <p:origin x="6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mertzidou, Anysia" userId="a7f71f62-1794-4728-88f7-f0b545a7c8aa" providerId="ADAL" clId="{8F1EAE9F-5AB6-4436-B997-BB77AC0D81F3}"/>
    <pc:docChg chg="modSld">
      <pc:chgData name="Semertzidou, Anysia" userId="a7f71f62-1794-4728-88f7-f0b545a7c8aa" providerId="ADAL" clId="{8F1EAE9F-5AB6-4436-B997-BB77AC0D81F3}" dt="2025-10-30T16:12:08.149" v="14" actId="113"/>
      <pc:docMkLst>
        <pc:docMk/>
      </pc:docMkLst>
      <pc:sldChg chg="addSp modSp mod">
        <pc:chgData name="Semertzidou, Anysia" userId="a7f71f62-1794-4728-88f7-f0b545a7c8aa" providerId="ADAL" clId="{8F1EAE9F-5AB6-4436-B997-BB77AC0D81F3}" dt="2025-10-30T16:12:08.149" v="14" actId="113"/>
        <pc:sldMkLst>
          <pc:docMk/>
          <pc:sldMk cId="2578365540" sldId="256"/>
        </pc:sldMkLst>
        <pc:spChg chg="add mod">
          <ac:chgData name="Semertzidou, Anysia" userId="a7f71f62-1794-4728-88f7-f0b545a7c8aa" providerId="ADAL" clId="{8F1EAE9F-5AB6-4436-B997-BB77AC0D81F3}" dt="2025-10-30T16:11:55.130" v="11" actId="113"/>
          <ac:spMkLst>
            <pc:docMk/>
            <pc:sldMk cId="2578365540" sldId="256"/>
            <ac:spMk id="2" creationId="{3140F07E-46A3-70EA-3A49-793361B6D652}"/>
          </ac:spMkLst>
        </pc:spChg>
        <pc:spChg chg="add mod">
          <ac:chgData name="Semertzidou, Anysia" userId="a7f71f62-1794-4728-88f7-f0b545a7c8aa" providerId="ADAL" clId="{8F1EAE9F-5AB6-4436-B997-BB77AC0D81F3}" dt="2025-10-30T16:12:08.149" v="14" actId="113"/>
          <ac:spMkLst>
            <pc:docMk/>
            <pc:sldMk cId="2578365540" sldId="256"/>
            <ac:spMk id="5" creationId="{7E271BA7-E923-FD11-0542-79520B1BCE94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1ED95-8A31-BBFF-1759-7F88B76BA0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625489E-3AA0-8F67-8895-5F1B1CF1FF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CF3D5B-4FD6-972F-2046-B0922CD37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9079A2-7837-9490-EA40-5B19DD8AD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A58597-917B-3569-5567-92957DA1B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5087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34F752-3BEE-5168-8E97-2F05825542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6D385E-C6D9-086B-0BBD-2B504E84F0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5180AB-5595-7C40-F688-595286362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7F1890-DB53-2469-DC07-A0397AFE2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CFBC66-A944-36C2-8E9C-989A0C4CA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8008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D18C88B-4E95-7FC7-4841-FC0795679A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D381E9-6FE6-8C31-31E4-BFED4C5EAF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DFA084-C3E2-1B6B-6618-7B83727F9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4B5E2A-179E-8725-275B-ADC1110FC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D14D5-1BA4-85DF-0DF9-17F65752D6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421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222BC8-13E3-53A0-4A86-0675E922A5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AAF0E7-4AAE-E432-E07B-A697368DE45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D93237-ED79-6320-7953-D72506415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654667-8BD0-61A9-AA10-DBEB71798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07F1E9-5CB0-3F8E-8E89-8DA8EBDBD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264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332D4-5570-D6DC-95C9-A330CD1162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B7D2ED-56B1-FEE0-2BFE-B51E3C9A57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258B12-8527-71BC-E6B1-837593752E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F47314-9483-B0CF-A304-77F69F6B8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F1A367-C9E4-2009-A935-F19D796CB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4884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368384-5FE1-5BD7-8EAC-53AD379717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E239E6-ED70-ED9D-C37C-5450391B94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F563CD-FBEA-BD5F-39B4-0A06E1145D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32AAE0-BB6F-5DFA-3C01-5C1ED1988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258CDB-CA26-C368-CF8A-14A6D453D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4E8C19-54C7-1AE0-33BA-B3C1B0C52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2121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D22F1-6F12-D045-A4EB-0A1EF33DA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671555-F0CD-20FF-0BA6-1D703546EA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ED0BDE-14B4-161B-8D57-34E1A2C441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E3EB84-A5AD-3CD4-2A3C-56A6ADD4EF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1222626-E994-4540-12FB-278CBD5121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8C69549-849C-B9BC-10C2-4BF62532D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7B6D5B-0185-23FA-CBDB-5687799F3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261AD8-9C35-468A-89FE-AF3C78090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3875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4FCF32-604D-69A9-3781-9757DEE8D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7CF621-9BE7-6F88-5E57-12935C92D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3F6643-0451-E837-5329-34B6C9A22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F01E87-6A34-B4D9-B7F5-AD55F840AA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9580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A0DD5B6-5DD6-C3E9-6E17-3BF5BFB5C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54B9E4-ABFE-9A22-2EE9-D2484E2E8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A57292-BF07-DDFF-7900-CCA84F863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5280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42FF6A-D27D-6D78-3B05-9ACC0C39A3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DA6FE2-785E-9CA9-BCA9-5BC0954B1F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AEBFD7-D86D-8F97-3D7C-DA3FF0AFDB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3AA245-1D40-2856-CC1D-56978D3EE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0C2456-F4DE-2A67-E69A-00C38A8F2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FD9803-97E0-8FA8-8D56-DDADE6BDF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145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372507-4440-64F2-C838-933726C4C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C184E53-C42F-D5BE-4C35-5ACFDDFEB1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8FD45C-CD82-34C9-5E5A-8C0701C68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5B042C-CDA2-F20F-E52F-A4F4191D7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76D0D0-7C92-5B81-99E9-7DC780160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2F5465-E25C-60AC-8237-8B3C3AC36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6155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1FB51AE-03F1-F11D-1031-BCC37401EC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62B70F-6600-68EC-778D-CD832A5C8D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5FA0DF-38A3-8155-6809-E0DE0B8E64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9522ABF-3D91-4CAE-8433-BE1D20C66766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D89C4B-2617-379C-3F40-6AD25F64C0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00CB2F-D67B-A45E-6944-153951F353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0736A5-6D17-40F1-B328-2B5A4C2B6D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7759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graph&#10;&#10;Description automatically generated">
            <a:extLst>
              <a:ext uri="{FF2B5EF4-FFF2-40B4-BE49-F238E27FC236}">
                <a16:creationId xmlns:a16="http://schemas.microsoft.com/office/drawing/2014/main" id="{407BACFA-62A8-4B29-989A-B4DC8732415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0245" y="2308225"/>
            <a:ext cx="5731510" cy="2241550"/>
          </a:xfrm>
          <a:prstGeom prst="rect">
            <a:avLst/>
          </a:prstGeom>
        </p:spPr>
      </p:pic>
      <p:sp>
        <p:nvSpPr>
          <p:cNvPr id="2" name="Text Box 20">
            <a:extLst>
              <a:ext uri="{FF2B5EF4-FFF2-40B4-BE49-F238E27FC236}">
                <a16:creationId xmlns:a16="http://schemas.microsoft.com/office/drawing/2014/main" id="{3140F07E-46A3-70EA-3A49-793361B6D652}"/>
              </a:ext>
            </a:extLst>
          </p:cNvPr>
          <p:cNvSpPr>
            <a:spLocks noChangeArrowheads="1"/>
          </p:cNvSpPr>
          <p:nvPr/>
        </p:nvSpPr>
        <p:spPr>
          <a:xfrm>
            <a:off x="3157169" y="4955658"/>
            <a:ext cx="5685155" cy="443583"/>
          </a:xfrm>
          <a:prstGeom prst="rect">
            <a:avLst/>
          </a:prstGeom>
          <a:solidFill>
            <a:srgbClr val="FFFFFF"/>
          </a:solidFill>
          <a:ln w="9525">
            <a:noFill/>
            <a:miter/>
          </a:ln>
        </p:spPr>
        <p:txBody>
          <a:bodyPr wrap="square" lIns="91440" tIns="45720" rIns="91440" bIns="45720" anchor="t">
            <a:spAutoFit/>
          </a:bodyPr>
          <a:lstStyle/>
          <a:p>
            <a:pPr algn="just">
              <a:lnSpc>
                <a:spcPct val="106000"/>
              </a:lnSpc>
              <a:spcAft>
                <a:spcPts val="800"/>
              </a:spcAft>
            </a:pPr>
            <a:r>
              <a:rPr lang="en-US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Supplementary Figure 6 shows </a:t>
            </a:r>
            <a:r>
              <a:rPr lang="en-US" sz="1100" i="1" kern="100" dirty="0"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a</a:t>
            </a:r>
            <a:r>
              <a:rPr lang="en-US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ge (a), stage (b) and grade (c) for the two endometrioid patient subgroups identified in Figure 4a.</a:t>
            </a:r>
            <a:endParaRPr lang="en-GB" sz="1100" kern="1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E271BA7-E923-FD11-0542-79520B1BCE94}"/>
              </a:ext>
            </a:extLst>
          </p:cNvPr>
          <p:cNvSpPr txBox="1"/>
          <p:nvPr/>
        </p:nvSpPr>
        <p:spPr>
          <a:xfrm>
            <a:off x="3096928" y="1562319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Calibri" panose="020F0502020204030204" pitchFamily="34" charset="0"/>
              </a:rPr>
              <a:t>Supplementary Figure 6 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2578365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mertzidou, Anysia</dc:creator>
  <cp:lastModifiedBy>Semertzidou, Anysia</cp:lastModifiedBy>
  <cp:revision>1</cp:revision>
  <dcterms:created xsi:type="dcterms:W3CDTF">2025-10-06T13:43:53Z</dcterms:created>
  <dcterms:modified xsi:type="dcterms:W3CDTF">2025-10-30T16:12:09Z</dcterms:modified>
</cp:coreProperties>
</file>